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9F0FC6-4172-40B4-9D3C-EEB37CD6A3E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8F953D-69BA-4E14-ABD2-6FC9987F0F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0B59E6-4547-4964-92F6-E739CD93B32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DC170D-9278-4124-92F5-FBF855C010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F02D0F-DBF2-43C5-8687-3D7A978405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172B45-856B-4D08-85E0-610BA34EB0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3EF667-1A29-4E11-9C17-B5CAD32F53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F656D-4DD8-4F2D-BE82-03E98A1A18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A5CB3-0231-4F39-B675-8DE7257E72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F98EC3-572F-4281-B671-9CEDDC9129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F76DC4-2E51-4463-8F1F-7539F378F5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0C25FA-A528-432C-8B79-F47DEB88EA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D499821-A7DB-4F53-8769-E77DA7596253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184C9EB-5137-49DE-82D4-C1FAD2BB318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" descr=""/>
          <p:cNvPicPr/>
          <p:nvPr/>
        </p:nvPicPr>
        <p:blipFill>
          <a:blip r:embed="rId1"/>
          <a:stretch/>
        </p:blipFill>
        <p:spPr>
          <a:xfrm>
            <a:off x="4103640" y="654120"/>
            <a:ext cx="2597040" cy="397512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1072"/>
          <p:cNvSpPr/>
          <p:nvPr/>
        </p:nvSpPr>
        <p:spPr>
          <a:xfrm>
            <a:off x="320760" y="4919760"/>
            <a:ext cx="8583480" cy="162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. A1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ntrol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M. smegmati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xpress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gf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lone. pMV261 containing P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ace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gf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pCK76) was electroporated into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wag31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Ms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deletion mutant express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wag31</a:t>
            </a:r>
            <a:r>
              <a:rPr b="0" i="1" lang="en-US" sz="1200" spc="-1" strike="noStrike" baseline="-25000">
                <a:solidFill>
                  <a:srgbClr val="000000"/>
                </a:solidFill>
                <a:latin typeface="Arial"/>
              </a:rPr>
              <a:t>Mtb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KMS41) under a tetracycline-inducible P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te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promoter. The resulting strain (KMS46) were grown in 7H9 liquid medium containing 20 ng tetracycline, and at early-log phase (approximate OD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600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= 0.2) cells were induced with 0.1% of acetamide for 3 hr before being transferred onto a glass slide and observed using an Olympus BX51 florescence microscope (Supplementary Table 1). Such localized structures of Wag31 in cells express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wag3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wag31T73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or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wag31T73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re not seen, indicating that those GFP-Wag31 localizations are not GFP artifact. Top, GFP signal from fluorescence microscopy; Middle, DIC image of the cells shown at the top panel; Bottom, overlap image of GFP signal and DIC. bar, 5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2795760" y="665280"/>
          <a:ext cx="3906720" cy="3956040"/>
        </p:xfrm>
        <a:graphic>
          <a:graphicData uri="http://schemas.openxmlformats.org/drawingml/2006/table">
            <a:tbl>
              <a:tblPr/>
              <a:tblGrid>
                <a:gridCol w="1314360"/>
                <a:gridCol w="2592360"/>
              </a:tblGrid>
              <a:tr h="13636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FP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427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C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4964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FP + DIC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93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Straight Connector 7"/>
          <p:cNvSpPr/>
          <p:nvPr/>
        </p:nvSpPr>
        <p:spPr>
          <a:xfrm>
            <a:off x="6362640" y="3162240"/>
            <a:ext cx="228600" cy="180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1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11T20:18:40Z</dcterms:created>
  <dc:creator>Office 2004 Test Drive User</dc:creator>
  <dc:description/>
  <dc:language>en-US</dc:language>
  <cp:lastModifiedBy>Choong-Min Kang</cp:lastModifiedBy>
  <cp:lastPrinted>2010-08-02T20:49:52Z</cp:lastPrinted>
  <dcterms:modified xsi:type="dcterms:W3CDTF">2010-12-16T14:45:44Z</dcterms:modified>
  <cp:revision>190</cp:revision>
  <dc:subject/>
  <dc:title>Slide 1</dc:title>
</cp:coreProperties>
</file>